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525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566"/>
    <p:restoredTop sz="93241"/>
  </p:normalViewPr>
  <p:slideViewPr>
    <p:cSldViewPr snapToGrid="0" snapToObjects="1" showGuides="1">
      <p:cViewPr varScale="1">
        <p:scale>
          <a:sx n="66" d="100"/>
          <a:sy n="66" d="100"/>
        </p:scale>
        <p:origin x="336" y="184"/>
      </p:cViewPr>
      <p:guideLst>
        <p:guide orient="horz" pos="1525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27809B-928A-304D-98B7-776A3D9E6F0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0C93C2A-4045-C943-9E41-0B8191DA402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32447C-CB3A-934F-A4D3-405237BFDA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EF52FA-5535-7645-B6EF-3B99C3C0AF04}" type="datetimeFigureOut">
              <a:rPr lang="en-US" smtClean="0"/>
              <a:t>3/3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4EA916-6984-F746-AF0E-C286504F2F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947542-30B8-6442-9AC7-74536D2E5C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30B5C-F66F-A04A-B202-367E247D5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87915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5C7D7A-1A3D-854E-B3DF-349BE06F5F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AE56DA7-1920-2343-B808-BDF957B8F2C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5B1CF0-41DF-C140-8D9E-0CE71B35F5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EF52FA-5535-7645-B6EF-3B99C3C0AF04}" type="datetimeFigureOut">
              <a:rPr lang="en-US" smtClean="0"/>
              <a:t>3/3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049AC8-EDFA-0546-93D5-B5BBBB2EA5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0A44C5-BDE5-A946-862F-8DEBDCDBC9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30B5C-F66F-A04A-B202-367E247D5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77180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A5DDDE5-9182-B54C-92ED-0598B45B196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4B384C2-9BF1-814A-9388-863A85D707B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266863-8984-8240-9B22-7BD2FB635E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EF52FA-5535-7645-B6EF-3B99C3C0AF04}" type="datetimeFigureOut">
              <a:rPr lang="en-US" smtClean="0"/>
              <a:t>3/3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35CE65-A5C3-7349-BE40-14869046B9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3BAFB9-361D-644F-81E2-FBE6F84D2C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30B5C-F66F-A04A-B202-367E247D5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13620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69D09D-3EB7-8846-AE9D-C8612B35CD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C4D61EB-5E29-CE41-8474-03783103589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1739F0-2E4E-DD43-AC77-90255B3167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EF52FA-5535-7645-B6EF-3B99C3C0AF04}" type="datetimeFigureOut">
              <a:rPr lang="en-US" smtClean="0"/>
              <a:t>3/3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65719F-6ACD-F448-9FD4-0A901987F6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F2A79C-7564-DD4B-9409-0492D728AA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30B5C-F66F-A04A-B202-367E247D5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58645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5EF092-58CF-0F43-8218-F98218EF78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120BAC0-FA43-4841-9D02-BF5703AFDB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304A9F-5479-D54E-A4AC-06C098D739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EF52FA-5535-7645-B6EF-3B99C3C0AF04}" type="datetimeFigureOut">
              <a:rPr lang="en-US" smtClean="0"/>
              <a:t>3/3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68B07B-E08F-0B49-B127-1846BBBB88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0C9907-AE5D-6F44-B4B7-57AA439C30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30B5C-F66F-A04A-B202-367E247D5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83750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782230-47A9-7B4A-941E-0455A02C7F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7443D77-DA96-8E45-B227-2C2C9930746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581552D-9E94-4248-83A4-11B3C20626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A0850A1-F4E1-1148-AAE1-E11A6E6E75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EF52FA-5535-7645-B6EF-3B99C3C0AF04}" type="datetimeFigureOut">
              <a:rPr lang="en-US" smtClean="0"/>
              <a:t>3/3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889A422-D7B8-C54F-91C1-C96FE6A86F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1C682C2-AFE9-DE44-8719-7455159550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30B5C-F66F-A04A-B202-367E247D5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36859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3C4755-B847-4A47-8EF9-B460B05348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80E017A-7E4C-4C4B-82AA-124546AF50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FF394E5-8C54-F84A-AD03-873F70BAB67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B480CB1-C3E6-9D43-9F14-4FC7621B20F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BC98DA5-833C-2547-BB51-774716416DD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89C4A72-B6AD-9E47-BE8C-BD00E0102E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EF52FA-5535-7645-B6EF-3B99C3C0AF04}" type="datetimeFigureOut">
              <a:rPr lang="en-US" smtClean="0"/>
              <a:t>3/3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87B255F-FF01-A041-9321-743D98E16B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36F165C-AD3F-2340-887E-530F448A2E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30B5C-F66F-A04A-B202-367E247D5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74679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175587-651B-0B4F-B288-6898BD6B3F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E7CE0ED-F7CC-C54D-8281-16C887BB2C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EF52FA-5535-7645-B6EF-3B99C3C0AF04}" type="datetimeFigureOut">
              <a:rPr lang="en-US" smtClean="0"/>
              <a:t>3/3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22ECF37-04AF-7D45-942E-E687D564F2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31EA8A5-87BB-4646-800B-49CF36B802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30B5C-F66F-A04A-B202-367E247D5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05259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4A7B78C-25E7-9549-BA35-1916B748D2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EF52FA-5535-7645-B6EF-3B99C3C0AF04}" type="datetimeFigureOut">
              <a:rPr lang="en-US" smtClean="0"/>
              <a:t>3/3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15BAA87-6F7D-5D49-94CE-3FBEEBC800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EB2C0BF-FB0E-5F4C-9886-B86885A8FB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30B5C-F66F-A04A-B202-367E247D5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97128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38D1D8-3768-CB4A-988E-EA09577F06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CA2B750-FC63-D046-B82A-2549A1466E7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CF106DA-56DF-4544-9921-68E5A182878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9AA17E-8C69-654D-9F62-F97027AB8B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EF52FA-5535-7645-B6EF-3B99C3C0AF04}" type="datetimeFigureOut">
              <a:rPr lang="en-US" smtClean="0"/>
              <a:t>3/3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57DA504-A7A7-D74E-BFD5-14965ED1A2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C43DD8B-6A6B-F644-8455-09736AB19D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30B5C-F66F-A04A-B202-367E247D5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64031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412DBF-F3E3-854E-AFC0-319DDBFB2A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564EC81-D0F4-EF47-B75D-7EDEC9AD7B7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D9CC1E8-FD3C-C44E-9D82-9E0DA6FD19A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976CC6E-85EC-4844-A7C8-4211E74711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EF52FA-5535-7645-B6EF-3B99C3C0AF04}" type="datetimeFigureOut">
              <a:rPr lang="en-US" smtClean="0"/>
              <a:t>3/3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48CDCAD-CB2A-BD41-A510-8E17303D51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98D8445-4A15-2245-B499-9D13752739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30B5C-F66F-A04A-B202-367E247D5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3276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A808E35-4111-4440-8B5A-B2FB520748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D30E0F2-40D5-5044-9F19-460B132F26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3EC8D0-462F-1C44-9B47-7026E279F64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EF52FA-5535-7645-B6EF-3B99C3C0AF04}" type="datetimeFigureOut">
              <a:rPr lang="en-US" smtClean="0"/>
              <a:t>3/3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ECBD2B-90E7-C34D-A9DC-72F114B5C0B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E1D03A-3D0E-BB42-A582-658A979528E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130B5C-F66F-A04A-B202-367E247D5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77287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ncbi.nlm.nih.gov/tools/cobalt/re_cobalt.cgi" TargetMode="External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885CD894-148C-0E44-A138-205C1AC5FD9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43157" y="229341"/>
            <a:ext cx="4313322" cy="5542843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2D1C0901-53B7-C544-ADAE-5DEBE1A46127}"/>
              </a:ext>
            </a:extLst>
          </p:cNvPr>
          <p:cNvSpPr txBox="1"/>
          <p:nvPr/>
        </p:nvSpPr>
        <p:spPr>
          <a:xfrm>
            <a:off x="0" y="5715741"/>
            <a:ext cx="1211297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Figure 1. Amino acid Glycine 724 conservation analysis. </a:t>
            </a:r>
            <a:r>
              <a:rPr lang="en-US" sz="1200" dirty="0"/>
              <a:t>Multiple protein sequence alignment showing the conservation of </a:t>
            </a:r>
            <a:r>
              <a:rPr lang="en-US" sz="1200" dirty="0" err="1"/>
              <a:t>Gly</a:t>
            </a:r>
            <a:r>
              <a:rPr lang="en-US" sz="1200" dirty="0"/>
              <a:t> 724 between different species including </a:t>
            </a:r>
            <a:r>
              <a:rPr lang="en-US" sz="1200" i="1" dirty="0"/>
              <a:t>Mus musculus, Rattus norvegicus, Gallus </a:t>
            </a:r>
            <a:r>
              <a:rPr lang="en-US" sz="1200" i="1" dirty="0" err="1"/>
              <a:t>gallus</a:t>
            </a:r>
            <a:r>
              <a:rPr lang="en-US" sz="1200" i="1" dirty="0"/>
              <a:t>, </a:t>
            </a:r>
            <a:r>
              <a:rPr lang="en-US" sz="1200" i="1" dirty="0" err="1"/>
              <a:t>Canis</a:t>
            </a:r>
            <a:r>
              <a:rPr lang="en-US" sz="1200" i="1" dirty="0"/>
              <a:t> lupus </a:t>
            </a:r>
            <a:r>
              <a:rPr lang="en-US" sz="1200" i="1" dirty="0" err="1"/>
              <a:t>familiaris</a:t>
            </a:r>
            <a:r>
              <a:rPr lang="en-US" sz="1200" i="1" dirty="0"/>
              <a:t>, Bos Taurus, </a:t>
            </a:r>
            <a:r>
              <a:rPr lang="en-US" sz="1200" i="1" dirty="0" err="1"/>
              <a:t>Sus</a:t>
            </a:r>
            <a:r>
              <a:rPr lang="en-US" sz="1200" i="1" dirty="0"/>
              <a:t> </a:t>
            </a:r>
            <a:r>
              <a:rPr lang="en-US" sz="1200" i="1" dirty="0" err="1"/>
              <a:t>scrofa</a:t>
            </a:r>
            <a:r>
              <a:rPr lang="en-US" sz="1200" i="1" dirty="0"/>
              <a:t>, </a:t>
            </a:r>
            <a:r>
              <a:rPr lang="en-US" sz="1200" i="1" dirty="0" err="1"/>
              <a:t>Macaca</a:t>
            </a:r>
            <a:r>
              <a:rPr lang="en-US" sz="1200" i="1" dirty="0"/>
              <a:t> </a:t>
            </a:r>
            <a:r>
              <a:rPr lang="en-US" sz="1200" i="1" dirty="0" err="1"/>
              <a:t>mulatta</a:t>
            </a:r>
            <a:r>
              <a:rPr lang="en-US" sz="1200" i="1" dirty="0"/>
              <a:t>,  Xenopus tropicalis, Pan troglodytes, </a:t>
            </a:r>
            <a:r>
              <a:rPr lang="en-US" sz="1200" i="1" dirty="0" err="1"/>
              <a:t>Ovis</a:t>
            </a:r>
            <a:r>
              <a:rPr lang="en-US" sz="1200" i="1" dirty="0"/>
              <a:t> </a:t>
            </a:r>
            <a:r>
              <a:rPr lang="en-US" sz="1200" i="1" dirty="0" err="1"/>
              <a:t>aries</a:t>
            </a:r>
            <a:r>
              <a:rPr lang="en-US" sz="1200" i="1" dirty="0"/>
              <a:t>, </a:t>
            </a:r>
            <a:r>
              <a:rPr lang="en-US" sz="1200" i="1" dirty="0" err="1"/>
              <a:t>Bubalus</a:t>
            </a:r>
            <a:r>
              <a:rPr lang="en-US" sz="1200" i="1" dirty="0"/>
              <a:t> </a:t>
            </a:r>
            <a:r>
              <a:rPr lang="en-US" sz="1200" i="1" dirty="0" err="1"/>
              <a:t>bubalis</a:t>
            </a:r>
            <a:r>
              <a:rPr lang="en-US" sz="1200" i="1" dirty="0"/>
              <a:t>, </a:t>
            </a:r>
            <a:r>
              <a:rPr lang="en-US" sz="1200" i="1" dirty="0" err="1"/>
              <a:t>Chelonia</a:t>
            </a:r>
            <a:r>
              <a:rPr lang="en-US" sz="1200" i="1" dirty="0"/>
              <a:t> </a:t>
            </a:r>
            <a:r>
              <a:rPr lang="en-US" sz="1200" i="1" dirty="0" err="1"/>
              <a:t>mydas</a:t>
            </a:r>
            <a:r>
              <a:rPr lang="en-US" sz="1200" i="1" dirty="0"/>
              <a:t>, Bos </a:t>
            </a:r>
            <a:r>
              <a:rPr lang="en-US" sz="1200" i="1" dirty="0" err="1"/>
              <a:t>mutus</a:t>
            </a:r>
            <a:r>
              <a:rPr lang="en-US" sz="1200" i="1" dirty="0"/>
              <a:t>, Callithrix </a:t>
            </a:r>
            <a:r>
              <a:rPr lang="en-US" sz="1200" i="1" dirty="0" err="1"/>
              <a:t>jacchus</a:t>
            </a:r>
            <a:r>
              <a:rPr lang="en-US" sz="1200" i="1" dirty="0"/>
              <a:t>, </a:t>
            </a:r>
            <a:r>
              <a:rPr lang="en-US" sz="1200" i="1" dirty="0" err="1"/>
              <a:t>Mustela</a:t>
            </a:r>
            <a:r>
              <a:rPr lang="en-US" sz="1200" i="1" dirty="0"/>
              <a:t> putorius </a:t>
            </a:r>
            <a:r>
              <a:rPr lang="en-US" sz="1200" i="1" dirty="0" err="1"/>
              <a:t>furo</a:t>
            </a:r>
            <a:r>
              <a:rPr lang="en-US" sz="1200" i="1" dirty="0"/>
              <a:t>, Equus </a:t>
            </a:r>
            <a:r>
              <a:rPr lang="en-US" sz="1200" i="1" dirty="0" err="1"/>
              <a:t>caballus</a:t>
            </a:r>
            <a:r>
              <a:rPr lang="en-US" sz="1200" i="1" dirty="0"/>
              <a:t>,  </a:t>
            </a:r>
            <a:r>
              <a:rPr lang="en-US" sz="1200" i="1" dirty="0" err="1"/>
              <a:t>Mesocricetus</a:t>
            </a:r>
            <a:r>
              <a:rPr lang="en-US" sz="1200" i="1" dirty="0"/>
              <a:t> auratus, </a:t>
            </a:r>
            <a:r>
              <a:rPr lang="en-US" sz="1200" i="1" dirty="0" err="1"/>
              <a:t>Trachemys</a:t>
            </a:r>
            <a:r>
              <a:rPr lang="en-US" sz="1200" i="1" dirty="0"/>
              <a:t> </a:t>
            </a:r>
            <a:r>
              <a:rPr lang="en-US" sz="1200" i="1" dirty="0" err="1"/>
              <a:t>scripta</a:t>
            </a:r>
            <a:r>
              <a:rPr lang="en-US" sz="1200" i="1" dirty="0"/>
              <a:t> </a:t>
            </a:r>
            <a:r>
              <a:rPr lang="en-US" sz="1200" i="1" dirty="0" err="1"/>
              <a:t>elegans</a:t>
            </a:r>
            <a:r>
              <a:rPr lang="en-US" sz="1200" i="1" dirty="0"/>
              <a:t>, </a:t>
            </a:r>
            <a:r>
              <a:rPr lang="en-US" sz="1200" i="1" dirty="0" err="1"/>
              <a:t>Rhinatrema</a:t>
            </a:r>
            <a:r>
              <a:rPr lang="en-US" sz="1200" i="1" dirty="0"/>
              <a:t> </a:t>
            </a:r>
            <a:r>
              <a:rPr lang="en-US" sz="1200" i="1" dirty="0" err="1"/>
              <a:t>bivittatum</a:t>
            </a:r>
            <a:r>
              <a:rPr lang="en-US" sz="1200" i="1" dirty="0"/>
              <a:t>, </a:t>
            </a:r>
            <a:r>
              <a:rPr lang="en-US" sz="1200" i="1" dirty="0" err="1"/>
              <a:t>Microcaecilia</a:t>
            </a:r>
            <a:r>
              <a:rPr lang="en-US" sz="1200" i="1" dirty="0"/>
              <a:t> unicolor, </a:t>
            </a:r>
            <a:r>
              <a:rPr lang="en-US" sz="1200" i="1" dirty="0" err="1"/>
              <a:t>Protopterus</a:t>
            </a:r>
            <a:r>
              <a:rPr lang="en-US" sz="1200" i="1" dirty="0"/>
              <a:t> </a:t>
            </a:r>
            <a:r>
              <a:rPr lang="en-US" sz="1200" i="1" dirty="0" err="1"/>
              <a:t>annectens</a:t>
            </a:r>
            <a:r>
              <a:rPr lang="en-US" sz="1200" i="1" dirty="0"/>
              <a:t>, </a:t>
            </a:r>
            <a:r>
              <a:rPr lang="en-US" sz="1200" i="1" dirty="0" err="1"/>
              <a:t>Bufo</a:t>
            </a:r>
            <a:r>
              <a:rPr lang="en-US" sz="1200" i="1" dirty="0"/>
              <a:t> </a:t>
            </a:r>
            <a:r>
              <a:rPr lang="en-US" sz="1200" i="1" dirty="0" err="1"/>
              <a:t>bufo</a:t>
            </a:r>
            <a:r>
              <a:rPr lang="en-US" sz="1200" i="1" dirty="0"/>
              <a:t>, Rana </a:t>
            </a:r>
            <a:r>
              <a:rPr lang="en-US" sz="1200" i="1" dirty="0" err="1"/>
              <a:t>temporaria</a:t>
            </a:r>
            <a:r>
              <a:rPr lang="en-US" sz="1200" i="1" dirty="0"/>
              <a:t>, </a:t>
            </a:r>
            <a:r>
              <a:rPr lang="en-US" sz="1200" i="1" dirty="0" err="1"/>
              <a:t>Caretta</a:t>
            </a:r>
            <a:r>
              <a:rPr lang="en-US" sz="1200" i="1" dirty="0"/>
              <a:t> </a:t>
            </a:r>
            <a:r>
              <a:rPr lang="en-US" sz="1200" i="1" dirty="0" err="1"/>
              <a:t>caretta</a:t>
            </a:r>
            <a:r>
              <a:rPr lang="en-US" sz="1200" i="1" dirty="0"/>
              <a:t>, </a:t>
            </a:r>
            <a:r>
              <a:rPr lang="en-US" sz="1200" i="1" dirty="0" err="1"/>
              <a:t>Chrysemys</a:t>
            </a:r>
            <a:r>
              <a:rPr lang="en-US" sz="1200" i="1" dirty="0"/>
              <a:t> </a:t>
            </a:r>
            <a:r>
              <a:rPr lang="en-US" sz="1200" i="1" dirty="0" err="1"/>
              <a:t>picta</a:t>
            </a:r>
            <a:r>
              <a:rPr lang="en-US" sz="1200" i="1" dirty="0"/>
              <a:t> </a:t>
            </a:r>
            <a:r>
              <a:rPr lang="en-US" sz="1200" i="1" dirty="0" err="1"/>
              <a:t>bellii</a:t>
            </a:r>
            <a:r>
              <a:rPr lang="en-US" sz="1200" i="1" dirty="0"/>
              <a:t>, Alligator </a:t>
            </a:r>
            <a:r>
              <a:rPr lang="en-US" sz="1200" i="1" dirty="0" err="1"/>
              <a:t>mississippiensis</a:t>
            </a:r>
            <a:r>
              <a:rPr lang="en-US" sz="1200" i="1" dirty="0"/>
              <a:t>, </a:t>
            </a:r>
            <a:r>
              <a:rPr lang="en-US" sz="1200" i="1" dirty="0" err="1"/>
              <a:t>Crocodylus</a:t>
            </a:r>
            <a:r>
              <a:rPr lang="en-US" sz="1200" i="1" dirty="0"/>
              <a:t> </a:t>
            </a:r>
            <a:r>
              <a:rPr lang="en-US" sz="1200" i="1" dirty="0" err="1"/>
              <a:t>porosus</a:t>
            </a:r>
            <a:r>
              <a:rPr lang="en-US" sz="1200" i="1" dirty="0"/>
              <a:t> </a:t>
            </a:r>
            <a:r>
              <a:rPr lang="en-US" sz="1200" dirty="0"/>
              <a:t>. The alignment was performed using COBALT online software (</a:t>
            </a:r>
            <a:r>
              <a:rPr lang="en-US" sz="1200" dirty="0">
                <a:hlinkClick r:id="rId3"/>
              </a:rPr>
              <a:t>https://www.ncbi.nlm.nih.gov/tools/cobalt/re_cobalt.cgi</a:t>
            </a:r>
            <a:r>
              <a:rPr lang="en-US" sz="1200" dirty="0"/>
              <a:t>). Mutated glycine is in the black box.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81B81314-B7B5-1E40-9F11-F082EE4986BD}"/>
              </a:ext>
            </a:extLst>
          </p:cNvPr>
          <p:cNvSpPr/>
          <p:nvPr/>
        </p:nvSpPr>
        <p:spPr>
          <a:xfrm>
            <a:off x="0" y="-35947"/>
            <a:ext cx="195297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/>
              <a:t>Supplementary Figure 1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6856829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19</TotalTime>
  <Words>152</Words>
  <Application>Microsoft Macintosh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Admin</cp:lastModifiedBy>
  <cp:revision>6</cp:revision>
  <dcterms:created xsi:type="dcterms:W3CDTF">2022-09-23T11:21:28Z</dcterms:created>
  <dcterms:modified xsi:type="dcterms:W3CDTF">2023-03-03T14:35:20Z</dcterms:modified>
</cp:coreProperties>
</file>